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264275" cy="84232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38A0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96" d="100"/>
          <a:sy n="96" d="100"/>
        </p:scale>
        <p:origin x="2862" y="-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41AE9-55CA-4EA4-A78F-BC692DB2F57A}" type="datetimeFigureOut">
              <a:rPr lang="es-MX" smtClean="0"/>
              <a:t>29/05/2025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790A1-3507-4574-BAFC-CBE953FF7C7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18869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41AE9-55CA-4EA4-A78F-BC692DB2F57A}" type="datetimeFigureOut">
              <a:rPr lang="es-MX" smtClean="0"/>
              <a:t>29/05/2025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790A1-3507-4574-BAFC-CBE953FF7C7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45130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41AE9-55CA-4EA4-A78F-BC692DB2F57A}" type="datetimeFigureOut">
              <a:rPr lang="es-MX" smtClean="0"/>
              <a:t>29/05/2025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790A1-3507-4574-BAFC-CBE953FF7C7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082107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41AE9-55CA-4EA4-A78F-BC692DB2F57A}" type="datetimeFigureOut">
              <a:rPr lang="es-MX" smtClean="0"/>
              <a:t>29/05/2025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790A1-3507-4574-BAFC-CBE953FF7C7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99861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41AE9-55CA-4EA4-A78F-BC692DB2F57A}" type="datetimeFigureOut">
              <a:rPr lang="es-MX" smtClean="0"/>
              <a:t>29/05/2025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790A1-3507-4574-BAFC-CBE953FF7C7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99648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41AE9-55CA-4EA4-A78F-BC692DB2F57A}" type="datetimeFigureOut">
              <a:rPr lang="es-MX" smtClean="0"/>
              <a:t>29/05/2025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790A1-3507-4574-BAFC-CBE953FF7C7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041109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41AE9-55CA-4EA4-A78F-BC692DB2F57A}" type="datetimeFigureOut">
              <a:rPr lang="es-MX" smtClean="0"/>
              <a:t>29/05/2025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790A1-3507-4574-BAFC-CBE953FF7C7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15785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41AE9-55CA-4EA4-A78F-BC692DB2F57A}" type="datetimeFigureOut">
              <a:rPr lang="es-MX" smtClean="0"/>
              <a:t>29/05/2025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790A1-3507-4574-BAFC-CBE953FF7C7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692573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41AE9-55CA-4EA4-A78F-BC692DB2F57A}" type="datetimeFigureOut">
              <a:rPr lang="es-MX" smtClean="0"/>
              <a:t>29/05/2025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790A1-3507-4574-BAFC-CBE953FF7C7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063341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41AE9-55CA-4EA4-A78F-BC692DB2F57A}" type="datetimeFigureOut">
              <a:rPr lang="es-MX" smtClean="0"/>
              <a:t>29/05/2025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790A1-3507-4574-BAFC-CBE953FF7C7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28241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41AE9-55CA-4EA4-A78F-BC692DB2F57A}" type="datetimeFigureOut">
              <a:rPr lang="es-MX" smtClean="0"/>
              <a:t>29/05/2025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D790A1-3507-4574-BAFC-CBE953FF7C7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07942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C41AE9-55CA-4EA4-A78F-BC692DB2F57A}" type="datetimeFigureOut">
              <a:rPr lang="es-MX" smtClean="0"/>
              <a:t>29/05/2025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D790A1-3507-4574-BAFC-CBE953FF7C76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12067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emf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2 CuadroTexto">
            <a:extLst>
              <a:ext uri="{FF2B5EF4-FFF2-40B4-BE49-F238E27FC236}">
                <a16:creationId xmlns:a16="http://schemas.microsoft.com/office/drawing/2014/main" id="{93C21163-B5D0-EA10-A90C-1820275F39DF}"/>
              </a:ext>
            </a:extLst>
          </p:cNvPr>
          <p:cNvSpPr txBox="1"/>
          <p:nvPr/>
        </p:nvSpPr>
        <p:spPr>
          <a:xfrm>
            <a:off x="219553" y="78618"/>
            <a:ext cx="3686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842345"/>
            <a:r>
              <a:rPr lang="es-MX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230" name="39 CuadroTexto">
            <a:extLst>
              <a:ext uri="{FF2B5EF4-FFF2-40B4-BE49-F238E27FC236}">
                <a16:creationId xmlns:a16="http://schemas.microsoft.com/office/drawing/2014/main" id="{5C44AA5F-C1C8-65BD-F0CB-0D38ADB79B4E}"/>
              </a:ext>
            </a:extLst>
          </p:cNvPr>
          <p:cNvSpPr txBox="1"/>
          <p:nvPr/>
        </p:nvSpPr>
        <p:spPr>
          <a:xfrm>
            <a:off x="3084624" y="43528"/>
            <a:ext cx="3906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842345"/>
            <a:r>
              <a:rPr lang="es-MX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233" name="40 CuadroTexto">
            <a:extLst>
              <a:ext uri="{FF2B5EF4-FFF2-40B4-BE49-F238E27FC236}">
                <a16:creationId xmlns:a16="http://schemas.microsoft.com/office/drawing/2014/main" id="{29882440-4479-419C-6C4B-45F359A95B15}"/>
              </a:ext>
            </a:extLst>
          </p:cNvPr>
          <p:cNvSpPr txBox="1"/>
          <p:nvPr/>
        </p:nvSpPr>
        <p:spPr>
          <a:xfrm>
            <a:off x="3057662" y="1663275"/>
            <a:ext cx="3906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842345"/>
            <a:r>
              <a:rPr lang="es-MX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166" name="Rectangle 6">
            <a:extLst>
              <a:ext uri="{FF2B5EF4-FFF2-40B4-BE49-F238E27FC236}">
                <a16:creationId xmlns:a16="http://schemas.microsoft.com/office/drawing/2014/main" id="{C52894D7-0A65-8663-F4FA-E71643626F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664403" y="3904137"/>
            <a:ext cx="170176" cy="3401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84233" tIns="42116" rIns="84233" bIns="42116" numCol="1" anchor="ctr" anchorCtr="0" compatLnSpc="1">
            <a:prstTxWarp prst="textNoShape">
              <a:avLst/>
            </a:prstTxWarp>
            <a:spAutoFit/>
          </a:bodyPr>
          <a:lstStyle/>
          <a:p>
            <a:pPr defTabSz="842345">
              <a:defRPr/>
            </a:pPr>
            <a:endParaRPr lang="es-MX" sz="1658" kern="0">
              <a:solidFill>
                <a:prstClr val="black"/>
              </a:solidFill>
            </a:endParaRPr>
          </a:p>
        </p:txBody>
      </p:sp>
      <p:sp>
        <p:nvSpPr>
          <p:cNvPr id="7" name="39 CuadroTexto">
            <a:extLst>
              <a:ext uri="{FF2B5EF4-FFF2-40B4-BE49-F238E27FC236}">
                <a16:creationId xmlns:a16="http://schemas.microsoft.com/office/drawing/2014/main" id="{7D9239D4-5554-9E0A-CF16-F0518082EF61}"/>
              </a:ext>
            </a:extLst>
          </p:cNvPr>
          <p:cNvSpPr txBox="1"/>
          <p:nvPr/>
        </p:nvSpPr>
        <p:spPr>
          <a:xfrm>
            <a:off x="223383" y="1663276"/>
            <a:ext cx="4377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842345"/>
            <a:r>
              <a:rPr lang="es-MX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33" name="2 CuadroTexto">
            <a:extLst>
              <a:ext uri="{FF2B5EF4-FFF2-40B4-BE49-F238E27FC236}">
                <a16:creationId xmlns:a16="http://schemas.microsoft.com/office/drawing/2014/main" id="{E44791FF-7380-949F-4E52-B505CFEA891D}"/>
              </a:ext>
            </a:extLst>
          </p:cNvPr>
          <p:cNvSpPr txBox="1"/>
          <p:nvPr/>
        </p:nvSpPr>
        <p:spPr>
          <a:xfrm>
            <a:off x="296320" y="3273841"/>
            <a:ext cx="4667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842345"/>
            <a:r>
              <a:rPr lang="es-MX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sp>
        <p:nvSpPr>
          <p:cNvPr id="35" name="40 CuadroTexto">
            <a:extLst>
              <a:ext uri="{FF2B5EF4-FFF2-40B4-BE49-F238E27FC236}">
                <a16:creationId xmlns:a16="http://schemas.microsoft.com/office/drawing/2014/main" id="{707D1D1F-A6D3-E0D7-8F58-A8F840CAB82C}"/>
              </a:ext>
            </a:extLst>
          </p:cNvPr>
          <p:cNvSpPr txBox="1"/>
          <p:nvPr/>
        </p:nvSpPr>
        <p:spPr>
          <a:xfrm>
            <a:off x="296320" y="4777786"/>
            <a:ext cx="4667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842345"/>
            <a:r>
              <a:rPr lang="es-MX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sp>
        <p:nvSpPr>
          <p:cNvPr id="36" name="39 CuadroTexto">
            <a:extLst>
              <a:ext uri="{FF2B5EF4-FFF2-40B4-BE49-F238E27FC236}">
                <a16:creationId xmlns:a16="http://schemas.microsoft.com/office/drawing/2014/main" id="{9C483790-4151-EA02-E463-40DFAFBA73C1}"/>
              </a:ext>
            </a:extLst>
          </p:cNvPr>
          <p:cNvSpPr txBox="1"/>
          <p:nvPr/>
        </p:nvSpPr>
        <p:spPr>
          <a:xfrm>
            <a:off x="3110455" y="3254483"/>
            <a:ext cx="364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842345"/>
            <a:r>
              <a:rPr lang="es-MX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</a:p>
        </p:txBody>
      </p:sp>
      <p:sp>
        <p:nvSpPr>
          <p:cNvPr id="41" name="40 CuadroTexto">
            <a:extLst>
              <a:ext uri="{FF2B5EF4-FFF2-40B4-BE49-F238E27FC236}">
                <a16:creationId xmlns:a16="http://schemas.microsoft.com/office/drawing/2014/main" id="{5BBDEEE9-102F-964B-B74A-2E3A3E66F2A8}"/>
              </a:ext>
            </a:extLst>
          </p:cNvPr>
          <p:cNvSpPr txBox="1"/>
          <p:nvPr/>
        </p:nvSpPr>
        <p:spPr>
          <a:xfrm>
            <a:off x="3085864" y="4777786"/>
            <a:ext cx="3894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842345"/>
            <a:r>
              <a:rPr lang="es-MX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pic>
        <p:nvPicPr>
          <p:cNvPr id="20" name="Imagen 19">
            <a:extLst>
              <a:ext uri="{FF2B5EF4-FFF2-40B4-BE49-F238E27FC236}">
                <a16:creationId xmlns:a16="http://schemas.microsoft.com/office/drawing/2014/main" id="{0E3477B3-B5C3-EC81-3FEA-C3E901D820C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5004" y="367377"/>
            <a:ext cx="2891247" cy="1240002"/>
          </a:xfrm>
          <a:prstGeom prst="rect">
            <a:avLst/>
          </a:prstGeom>
        </p:spPr>
      </p:pic>
      <p:pic>
        <p:nvPicPr>
          <p:cNvPr id="21" name="Imagen 20">
            <a:extLst>
              <a:ext uri="{FF2B5EF4-FFF2-40B4-BE49-F238E27FC236}">
                <a16:creationId xmlns:a16="http://schemas.microsoft.com/office/drawing/2014/main" id="{11074C22-19A8-C0EF-7FCE-ED21D4D656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91300" y="367836"/>
            <a:ext cx="2890452" cy="1239662"/>
          </a:xfrm>
          <a:prstGeom prst="rect">
            <a:avLst/>
          </a:prstGeom>
        </p:spPr>
      </p:pic>
      <p:pic>
        <p:nvPicPr>
          <p:cNvPr id="22" name="Imagen 21">
            <a:extLst>
              <a:ext uri="{FF2B5EF4-FFF2-40B4-BE49-F238E27FC236}">
                <a16:creationId xmlns:a16="http://schemas.microsoft.com/office/drawing/2014/main" id="{DEED8C80-997A-FD42-374B-3E91F688E9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5709" y="1957062"/>
            <a:ext cx="2899101" cy="1243372"/>
          </a:xfrm>
          <a:prstGeom prst="rect">
            <a:avLst/>
          </a:prstGeom>
        </p:spPr>
      </p:pic>
      <p:pic>
        <p:nvPicPr>
          <p:cNvPr id="23" name="Imagen 22">
            <a:extLst>
              <a:ext uri="{FF2B5EF4-FFF2-40B4-BE49-F238E27FC236}">
                <a16:creationId xmlns:a16="http://schemas.microsoft.com/office/drawing/2014/main" id="{A40FF21A-F69C-D636-F901-05755025A1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81519" y="1954961"/>
            <a:ext cx="2899104" cy="1243372"/>
          </a:xfrm>
          <a:prstGeom prst="rect">
            <a:avLst/>
          </a:prstGeom>
        </p:spPr>
      </p:pic>
      <p:pic>
        <p:nvPicPr>
          <p:cNvPr id="26" name="Imagen 25">
            <a:extLst>
              <a:ext uri="{FF2B5EF4-FFF2-40B4-BE49-F238E27FC236}">
                <a16:creationId xmlns:a16="http://schemas.microsoft.com/office/drawing/2014/main" id="{1ABE2686-516E-8D1D-7ADA-A2EA78E4BE7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7333" y="3565890"/>
            <a:ext cx="2897478" cy="1127390"/>
          </a:xfrm>
          <a:prstGeom prst="rect">
            <a:avLst/>
          </a:prstGeom>
        </p:spPr>
      </p:pic>
      <p:pic>
        <p:nvPicPr>
          <p:cNvPr id="28" name="Imagen 27">
            <a:extLst>
              <a:ext uri="{FF2B5EF4-FFF2-40B4-BE49-F238E27FC236}">
                <a16:creationId xmlns:a16="http://schemas.microsoft.com/office/drawing/2014/main" id="{6AC3910F-C6B1-BEDF-45F9-E5E4DB65E44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79975" y="3565890"/>
            <a:ext cx="2899103" cy="1128057"/>
          </a:xfrm>
          <a:prstGeom prst="rect">
            <a:avLst/>
          </a:prstGeom>
        </p:spPr>
      </p:pic>
      <p:pic>
        <p:nvPicPr>
          <p:cNvPr id="29" name="Imagen 28">
            <a:extLst>
              <a:ext uri="{FF2B5EF4-FFF2-40B4-BE49-F238E27FC236}">
                <a16:creationId xmlns:a16="http://schemas.microsoft.com/office/drawing/2014/main" id="{CF93917A-DDDD-04D9-8414-B41C757839D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7466" y="5072298"/>
            <a:ext cx="2899101" cy="1130500"/>
          </a:xfrm>
          <a:prstGeom prst="rect">
            <a:avLst/>
          </a:prstGeom>
        </p:spPr>
      </p:pic>
      <p:pic>
        <p:nvPicPr>
          <p:cNvPr id="30" name="Imagen 29">
            <a:extLst>
              <a:ext uri="{FF2B5EF4-FFF2-40B4-BE49-F238E27FC236}">
                <a16:creationId xmlns:a16="http://schemas.microsoft.com/office/drawing/2014/main" id="{5284B6C1-6E2F-2A5C-7941-2ADF196C73C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180770" y="5068788"/>
            <a:ext cx="2899103" cy="1129078"/>
          </a:xfrm>
          <a:prstGeom prst="rect">
            <a:avLst/>
          </a:prstGeom>
        </p:spPr>
      </p:pic>
      <p:sp>
        <p:nvSpPr>
          <p:cNvPr id="2" name="40 CuadroTexto">
            <a:extLst>
              <a:ext uri="{FF2B5EF4-FFF2-40B4-BE49-F238E27FC236}">
                <a16:creationId xmlns:a16="http://schemas.microsoft.com/office/drawing/2014/main" id="{209C5F96-CCC8-52A6-7F67-6415E9B0B5E5}"/>
              </a:ext>
            </a:extLst>
          </p:cNvPr>
          <p:cNvSpPr txBox="1"/>
          <p:nvPr/>
        </p:nvSpPr>
        <p:spPr>
          <a:xfrm>
            <a:off x="243008" y="6216138"/>
            <a:ext cx="363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842345"/>
            <a:r>
              <a:rPr lang="es-MX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i)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900972BB-5874-E316-703E-18AD9381051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98166" y="6238494"/>
            <a:ext cx="1394154" cy="2070608"/>
          </a:xfrm>
          <a:prstGeom prst="rect">
            <a:avLst/>
          </a:prstGeom>
        </p:spPr>
      </p:pic>
      <p:graphicFrame>
        <p:nvGraphicFramePr>
          <p:cNvPr id="4" name="Tabla 3">
            <a:extLst>
              <a:ext uri="{FF2B5EF4-FFF2-40B4-BE49-F238E27FC236}">
                <a16:creationId xmlns:a16="http://schemas.microsoft.com/office/drawing/2014/main" id="{E88FBDF9-B8D8-77EA-6661-342A15467F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47223705"/>
              </p:ext>
            </p:extLst>
          </p:nvPr>
        </p:nvGraphicFramePr>
        <p:xfrm>
          <a:off x="3373291" y="6354638"/>
          <a:ext cx="2647975" cy="126903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47975">
                  <a:extLst>
                    <a:ext uri="{9D8B030D-6E8A-4147-A177-3AD203B41FA5}">
                      <a16:colId xmlns:a16="http://schemas.microsoft.com/office/drawing/2014/main" val="24869645"/>
                    </a:ext>
                  </a:extLst>
                </a:gridCol>
              </a:tblGrid>
              <a:tr h="281273">
                <a:tc>
                  <a:txBody>
                    <a:bodyPr/>
                    <a:lstStyle/>
                    <a:p>
                      <a:pPr algn="l"/>
                      <a:r>
                        <a:rPr lang="es-MX" sz="1100" b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ES</a:t>
                      </a:r>
                      <a:endParaRPr lang="es-MX" sz="11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9484167"/>
                  </a:ext>
                </a:extLst>
              </a:tr>
              <a:tr h="281273">
                <a:tc>
                  <a:txBody>
                    <a:bodyPr/>
                    <a:lstStyle/>
                    <a:p>
                      <a:r>
                        <a:rPr lang="es-MX" sz="11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ES</a:t>
                      </a:r>
                      <a:r>
                        <a:rPr lang="es-MX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MX" sz="11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</a:t>
                      </a:r>
                      <a:r>
                        <a:rPr lang="es-MX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s-MX" sz="11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bohydrates</a:t>
                      </a:r>
                      <a:r>
                        <a:rPr lang="es-MX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8694183"/>
                  </a:ext>
                </a:extLst>
              </a:tr>
              <a:tr h="281273">
                <a:tc>
                  <a:txBody>
                    <a:bodyPr/>
                    <a:lstStyle/>
                    <a:p>
                      <a:r>
                        <a:rPr lang="es-MX" sz="11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ES</a:t>
                      </a:r>
                      <a:r>
                        <a:rPr lang="es-MX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MX" sz="11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o</a:t>
                      </a:r>
                      <a:r>
                        <a:rPr lang="es-MX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s-MX" sz="11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bohydrates</a:t>
                      </a:r>
                      <a:r>
                        <a:rPr lang="es-MX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2811440"/>
                  </a:ext>
                </a:extLst>
              </a:tr>
              <a:tr h="425214">
                <a:tc>
                  <a:txBody>
                    <a:bodyPr/>
                    <a:lstStyle/>
                    <a:p>
                      <a:r>
                        <a:rPr lang="es-MX" sz="11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ucose</a:t>
                      </a:r>
                      <a:r>
                        <a:rPr lang="es-MX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MX" sz="11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nose</a:t>
                      </a:r>
                      <a:r>
                        <a:rPr lang="es-MX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r>
                        <a:rPr lang="es-MX" sz="11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lactose</a:t>
                      </a:r>
                      <a:r>
                        <a:rPr lang="es-MX" sz="11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nd </a:t>
                      </a:r>
                      <a:r>
                        <a:rPr lang="es-MX" sz="11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uctose</a:t>
                      </a:r>
                      <a:endParaRPr lang="es-MX" sz="11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7697655"/>
                  </a:ext>
                </a:extLst>
              </a:tr>
            </a:tbl>
          </a:graphicData>
        </a:graphic>
      </p:graphicFrame>
      <p:cxnSp>
        <p:nvCxnSpPr>
          <p:cNvPr id="6" name="Conector recto 5">
            <a:extLst>
              <a:ext uri="{FF2B5EF4-FFF2-40B4-BE49-F238E27FC236}">
                <a16:creationId xmlns:a16="http://schemas.microsoft.com/office/drawing/2014/main" id="{ED47F5B4-6DC0-B01E-591F-76A8F196EC0A}"/>
              </a:ext>
            </a:extLst>
          </p:cNvPr>
          <p:cNvCxnSpPr>
            <a:cxnSpLocks/>
          </p:cNvCxnSpPr>
          <p:nvPr/>
        </p:nvCxnSpPr>
        <p:spPr>
          <a:xfrm>
            <a:off x="2668860" y="6493137"/>
            <a:ext cx="61661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7">
            <a:extLst>
              <a:ext uri="{FF2B5EF4-FFF2-40B4-BE49-F238E27FC236}">
                <a16:creationId xmlns:a16="http://schemas.microsoft.com/office/drawing/2014/main" id="{34F13185-D93B-3275-E62A-3F91644A26EB}"/>
              </a:ext>
            </a:extLst>
          </p:cNvPr>
          <p:cNvCxnSpPr>
            <a:cxnSpLocks/>
          </p:cNvCxnSpPr>
          <p:nvPr/>
        </p:nvCxnSpPr>
        <p:spPr>
          <a:xfrm>
            <a:off x="2675210" y="6785237"/>
            <a:ext cx="610269" cy="0"/>
          </a:xfrm>
          <a:prstGeom prst="line">
            <a:avLst/>
          </a:prstGeom>
          <a:ln w="38100"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ector recto 8">
            <a:extLst>
              <a:ext uri="{FF2B5EF4-FFF2-40B4-BE49-F238E27FC236}">
                <a16:creationId xmlns:a16="http://schemas.microsoft.com/office/drawing/2014/main" id="{B1739D65-151E-2649-3642-6105715C4495}"/>
              </a:ext>
            </a:extLst>
          </p:cNvPr>
          <p:cNvCxnSpPr>
            <a:cxnSpLocks/>
          </p:cNvCxnSpPr>
          <p:nvPr/>
        </p:nvCxnSpPr>
        <p:spPr>
          <a:xfrm>
            <a:off x="2668860" y="7070987"/>
            <a:ext cx="616619" cy="0"/>
          </a:xfrm>
          <a:prstGeom prst="line">
            <a:avLst/>
          </a:prstGeom>
          <a:ln w="38100">
            <a:solidFill>
              <a:srgbClr val="E38A0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9">
            <a:extLst>
              <a:ext uri="{FF2B5EF4-FFF2-40B4-BE49-F238E27FC236}">
                <a16:creationId xmlns:a16="http://schemas.microsoft.com/office/drawing/2014/main" id="{7D4FE499-0790-161B-2B9D-20D02C225CF8}"/>
              </a:ext>
            </a:extLst>
          </p:cNvPr>
          <p:cNvCxnSpPr>
            <a:cxnSpLocks/>
          </p:cNvCxnSpPr>
          <p:nvPr/>
        </p:nvCxnSpPr>
        <p:spPr>
          <a:xfrm>
            <a:off x="2662510" y="7385835"/>
            <a:ext cx="634294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14018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Tema de 2022">
  <a:themeElements>
    <a:clrScheme name="Office 2013 - Tema de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Tema de 2022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Tema de 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184</TotalTime>
  <Words>45</Words>
  <Application>Microsoft Office PowerPoint</Application>
  <PresentationFormat>Personalizado</PresentationFormat>
  <Paragraphs>1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Tema de 2022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YADIRA LEDESMA SOTO</dc:creator>
  <cp:lastModifiedBy>YADIRA LEDESMA SOTO</cp:lastModifiedBy>
  <cp:revision>33</cp:revision>
  <dcterms:created xsi:type="dcterms:W3CDTF">2022-06-28T14:01:21Z</dcterms:created>
  <dcterms:modified xsi:type="dcterms:W3CDTF">2025-05-29T22:38:25Z</dcterms:modified>
</cp:coreProperties>
</file>